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2426" autoAdjust="0"/>
    <p:restoredTop sz="94660"/>
  </p:normalViewPr>
  <p:slideViewPr>
    <p:cSldViewPr showGuides="1">
      <p:cViewPr>
        <p:scale>
          <a:sx n="100" d="100"/>
          <a:sy n="100" d="100"/>
        </p:scale>
        <p:origin x="-2088" y="-78"/>
      </p:cViewPr>
      <p:guideLst>
        <p:guide orient="horz" pos="5375"/>
        <p:guide pos="43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226210-E081-44F8-84E3-1DA22AAEFD7F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16AEF4-CE79-4333-8518-D9C3986F988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5601724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616262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27951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055220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53150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281438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13109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594858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58987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34073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831194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370070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52ED0-638F-4BA4-AB06-A12DDF42EAF8}" type="datetimeFigureOut">
              <a:rPr lang="en-GB" smtClean="0"/>
              <a:pPr/>
              <a:t>19/08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D53AC5-0BA9-4571-B2F8-171F83E54F0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53080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01440" y="1002958"/>
            <a:ext cx="352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.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837113" y="4387334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.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837113" y="7702174"/>
            <a:ext cx="54175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Key. </a:t>
            </a:r>
            <a:r>
              <a:rPr lang="en-GB" sz="1200" dirty="0" smtClean="0"/>
              <a:t>Growth media: A, HOMEM; - </a:t>
            </a:r>
            <a:r>
              <a:rPr lang="en-GB" sz="1200" dirty="0" err="1" smtClean="0"/>
              <a:t>Trp</a:t>
            </a:r>
            <a:r>
              <a:rPr lang="en-GB" sz="1200" dirty="0" smtClean="0"/>
              <a:t>, HOMEM without tryptophan; - </a:t>
            </a:r>
            <a:r>
              <a:rPr lang="en-GB" sz="1200" dirty="0" err="1" smtClean="0"/>
              <a:t>Arg</a:t>
            </a:r>
            <a:r>
              <a:rPr lang="en-GB" sz="1200" dirty="0" smtClean="0"/>
              <a:t>, HOMEM without </a:t>
            </a:r>
            <a:r>
              <a:rPr lang="en-GB" sz="1200" dirty="0" err="1" smtClean="0"/>
              <a:t>arginine</a:t>
            </a:r>
            <a:r>
              <a:rPr lang="en-GB" sz="1200" dirty="0" smtClean="0"/>
              <a:t>; C, </a:t>
            </a:r>
            <a:r>
              <a:rPr lang="en-GB" sz="1200" dirty="0" err="1" smtClean="0"/>
              <a:t>mHOMEM</a:t>
            </a:r>
            <a:r>
              <a:rPr lang="en-GB" sz="1200" dirty="0" smtClean="0"/>
              <a:t>.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263233" y="107504"/>
            <a:ext cx="43260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S12 Fig. </a:t>
            </a:r>
            <a:r>
              <a:rPr lang="en-GB" b="1" dirty="0" smtClean="0"/>
              <a:t>Comparison of growth of </a:t>
            </a:r>
            <a:r>
              <a:rPr lang="en-GB" b="1" i="1" dirty="0" smtClean="0"/>
              <a:t>L. major</a:t>
            </a:r>
            <a:r>
              <a:rPr lang="en-GB" b="1" dirty="0" smtClean="0"/>
              <a:t> in media with different concentrations of amino acids.</a:t>
            </a:r>
            <a:endParaRPr lang="en-GB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268413" y="1187624"/>
            <a:ext cx="4166368" cy="30677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263232" y="4558784"/>
            <a:ext cx="4171549" cy="30677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xmlns="" val="665462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7</TotalTime>
  <Words>50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eth Westrop</dc:creator>
  <cp:lastModifiedBy>Graham Coombs</cp:lastModifiedBy>
  <cp:revision>34</cp:revision>
  <dcterms:created xsi:type="dcterms:W3CDTF">2015-04-30T15:02:01Z</dcterms:created>
  <dcterms:modified xsi:type="dcterms:W3CDTF">2015-08-19T08:59:09Z</dcterms:modified>
</cp:coreProperties>
</file>